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74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9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749300"/>
            <a:ext cx="2806700" cy="37433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BE942-E908-4AA3-ACE1-A14A842573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292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25700" y="2523634"/>
            <a:ext cx="6499015" cy="2459229"/>
            <a:chOff x="434266" y="697845"/>
            <a:chExt cx="8665353" cy="3278971"/>
          </a:xfrm>
        </p:grpSpPr>
        <p:grpSp>
          <p:nvGrpSpPr>
            <p:cNvPr id="9" name="Gruppieren 8"/>
            <p:cNvGrpSpPr/>
            <p:nvPr/>
          </p:nvGrpSpPr>
          <p:grpSpPr>
            <a:xfrm>
              <a:off x="434266" y="928678"/>
              <a:ext cx="8175666" cy="3048138"/>
              <a:chOff x="434266" y="797873"/>
              <a:chExt cx="8175666" cy="3048138"/>
            </a:xfrm>
          </p:grpSpPr>
          <p:grpSp>
            <p:nvGrpSpPr>
              <p:cNvPr id="8" name="Gruppieren 7"/>
              <p:cNvGrpSpPr/>
              <p:nvPr/>
            </p:nvGrpSpPr>
            <p:grpSpPr>
              <a:xfrm>
                <a:off x="434266" y="797873"/>
                <a:ext cx="8175666" cy="3048138"/>
                <a:chOff x="434266" y="797873"/>
                <a:chExt cx="8175666" cy="3048138"/>
              </a:xfrm>
            </p:grpSpPr>
            <p:sp>
              <p:nvSpPr>
                <p:cNvPr id="4" name="Textfeld 3"/>
                <p:cNvSpPr txBox="1"/>
                <p:nvPr/>
              </p:nvSpPr>
              <p:spPr>
                <a:xfrm>
                  <a:off x="434266" y="797873"/>
                  <a:ext cx="2597772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pplementary</a:t>
                  </a:r>
                  <a:r>
                    <a:rPr lang="de-DE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e-DE" sz="10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igure</a:t>
                  </a:r>
                  <a:r>
                    <a:rPr lang="de-DE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</a:t>
                  </a:r>
                  <a:endParaRPr 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9226" name="Picture 10"/>
                <p:cNvPicPr preferRelativeResize="0">
                  <a:picLocks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981733" y="1647095"/>
                  <a:ext cx="2541600" cy="1897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224" name="Picture 8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67774" y="1653194"/>
                  <a:ext cx="2541600" cy="1897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222" name="Picture 6"/>
                <p:cNvPicPr preferRelativeResize="0">
                  <a:picLocks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98645" y="1636615"/>
                  <a:ext cx="2541600" cy="1897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" name="Textfeld 9"/>
                <p:cNvSpPr txBox="1"/>
                <p:nvPr/>
              </p:nvSpPr>
              <p:spPr>
                <a:xfrm>
                  <a:off x="846073" y="1382617"/>
                  <a:ext cx="2597772" cy="2923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1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de-DE" sz="825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cal</a:t>
                  </a:r>
                  <a:r>
                    <a:rPr lang="de-DE" sz="825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ndritic</a:t>
                  </a:r>
                  <a:r>
                    <a:rPr lang="de-DE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pines</a:t>
                  </a:r>
                  <a:endParaRPr lang="en-US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feld 13"/>
                <p:cNvSpPr txBox="1"/>
                <p:nvPr/>
              </p:nvSpPr>
              <p:spPr>
                <a:xfrm>
                  <a:off x="3417840" y="1382617"/>
                  <a:ext cx="2597772" cy="2923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1 </a:t>
                  </a:r>
                  <a:r>
                    <a:rPr lang="de-DE" sz="825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sal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ndritic</a:t>
                  </a:r>
                  <a:r>
                    <a:rPr lang="de-DE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pines</a:t>
                  </a:r>
                  <a:endParaRPr lang="en-US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Textfeld 14"/>
                <p:cNvSpPr txBox="1"/>
                <p:nvPr/>
              </p:nvSpPr>
              <p:spPr>
                <a:xfrm>
                  <a:off x="6012160" y="1375005"/>
                  <a:ext cx="2597772" cy="2923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ntate</a:t>
                  </a:r>
                  <a:r>
                    <a:rPr lang="de-DE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de-DE" sz="825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yrus</a:t>
                  </a:r>
                  <a:endParaRPr lang="en-US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6" name="Gruppieren 15"/>
                <p:cNvGrpSpPr/>
                <p:nvPr/>
              </p:nvGrpSpPr>
              <p:grpSpPr>
                <a:xfrm>
                  <a:off x="1152543" y="3426456"/>
                  <a:ext cx="2133704" cy="369332"/>
                  <a:chOff x="6618547" y="3008109"/>
                  <a:chExt cx="2029654" cy="369332"/>
                </a:xfrm>
                <a:noFill/>
              </p:grpSpPr>
              <p:sp>
                <p:nvSpPr>
                  <p:cNvPr id="18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15616" y="3032086"/>
                    <a:ext cx="514343" cy="246223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31731" y="3008109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13986" y="3025904"/>
                    <a:ext cx="619638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18547" y="3017821"/>
                    <a:ext cx="552297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2" name="Gruppieren 31"/>
                <p:cNvGrpSpPr/>
                <p:nvPr/>
              </p:nvGrpSpPr>
              <p:grpSpPr>
                <a:xfrm>
                  <a:off x="3733459" y="3453588"/>
                  <a:ext cx="2125691" cy="369332"/>
                  <a:chOff x="6626169" y="3008109"/>
                  <a:chExt cx="2022032" cy="369332"/>
                </a:xfrm>
                <a:noFill/>
              </p:grpSpPr>
              <p:sp>
                <p:nvSpPr>
                  <p:cNvPr id="33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45719" y="3025904"/>
                    <a:ext cx="495520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31731" y="3008109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13986" y="3025904"/>
                    <a:ext cx="619638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26169" y="3017821"/>
                    <a:ext cx="544675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46" name="Gruppieren 45"/>
                <p:cNvGrpSpPr/>
                <p:nvPr/>
              </p:nvGrpSpPr>
              <p:grpSpPr>
                <a:xfrm>
                  <a:off x="6331859" y="3476679"/>
                  <a:ext cx="2201221" cy="369332"/>
                  <a:chOff x="6589467" y="3008109"/>
                  <a:chExt cx="2093878" cy="369332"/>
                </a:xfrm>
                <a:noFill/>
              </p:grpSpPr>
              <p:sp>
                <p:nvSpPr>
                  <p:cNvPr id="47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09979" y="3025904"/>
                    <a:ext cx="540046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66875" y="3008109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46976" y="3025904"/>
                    <a:ext cx="630579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89467" y="3017821"/>
                    <a:ext cx="581377" cy="24622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55" name="Textfeld 54"/>
              <p:cNvSpPr txBox="1"/>
              <p:nvPr/>
            </p:nvSpPr>
            <p:spPr>
              <a:xfrm>
                <a:off x="609831" y="1128680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3169848" y="1137916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5809374" y="1113396"/>
                <a:ext cx="472483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825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</a:t>
                </a:r>
                <a:endParaRPr lang="en-US" sz="825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0" name="Rechteck 29"/>
            <p:cNvSpPr/>
            <p:nvPr/>
          </p:nvSpPr>
          <p:spPr>
            <a:xfrm>
              <a:off x="2671514" y="697845"/>
              <a:ext cx="6428105" cy="67710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nchez-Mendoza, et al.</a:t>
              </a:r>
              <a:endParaRPr 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feron-α and TLR3 activation-induced depression associated with compromised hippocampal plastic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16765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9</Words>
  <Application>Microsoft Office PowerPoint</Application>
  <PresentationFormat>On-screen Show (4:3)</PresentationFormat>
  <Paragraphs>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0</cp:revision>
  <cp:lastPrinted>2019-03-06T11:43:59Z</cp:lastPrinted>
  <dcterms:created xsi:type="dcterms:W3CDTF">2018-09-05T14:08:24Z</dcterms:created>
  <dcterms:modified xsi:type="dcterms:W3CDTF">2020-05-22T07:19:31Z</dcterms:modified>
</cp:coreProperties>
</file>